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7C3268-3831-4CAA-9A06-3E5CFDC226C2}" v="3" dt="2024-05-21T13:12:03.29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3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min Hyun" userId="0288e339-f229-4ef7-af6c-9105033c7845" providerId="ADAL" clId="{757C3268-3831-4CAA-9A06-3E5CFDC226C2}"/>
    <pc:docChg chg="modSld">
      <pc:chgData name="Jimin Hyun" userId="0288e339-f229-4ef7-af6c-9105033c7845" providerId="ADAL" clId="{757C3268-3831-4CAA-9A06-3E5CFDC226C2}" dt="2024-05-21T13:12:07.911" v="8" actId="1076"/>
      <pc:docMkLst>
        <pc:docMk/>
      </pc:docMkLst>
      <pc:sldChg chg="addSp modSp mod">
        <pc:chgData name="Jimin Hyun" userId="0288e339-f229-4ef7-af6c-9105033c7845" providerId="ADAL" clId="{757C3268-3831-4CAA-9A06-3E5CFDC226C2}" dt="2024-05-21T13:12:07.911" v="8" actId="1076"/>
        <pc:sldMkLst>
          <pc:docMk/>
          <pc:sldMk cId="1023201734" sldId="256"/>
        </pc:sldMkLst>
        <pc:cxnChg chg="add mod">
          <ac:chgData name="Jimin Hyun" userId="0288e339-f229-4ef7-af6c-9105033c7845" providerId="ADAL" clId="{757C3268-3831-4CAA-9A06-3E5CFDC226C2}" dt="2024-05-21T13:11:41.833" v="1" actId="208"/>
          <ac:cxnSpMkLst>
            <pc:docMk/>
            <pc:sldMk cId="1023201734" sldId="256"/>
            <ac:cxnSpMk id="3" creationId="{BB3A98C2-9172-1954-098F-41944A5D5CCB}"/>
          </ac:cxnSpMkLst>
        </pc:cxnChg>
        <pc:cxnChg chg="add mod">
          <ac:chgData name="Jimin Hyun" userId="0288e339-f229-4ef7-af6c-9105033c7845" providerId="ADAL" clId="{757C3268-3831-4CAA-9A06-3E5CFDC226C2}" dt="2024-05-21T13:11:49.154" v="3" actId="1076"/>
          <ac:cxnSpMkLst>
            <pc:docMk/>
            <pc:sldMk cId="1023201734" sldId="256"/>
            <ac:cxnSpMk id="4" creationId="{CFCC225B-554D-AAA9-03EA-E8A154699B33}"/>
          </ac:cxnSpMkLst>
        </pc:cxnChg>
        <pc:cxnChg chg="add mod">
          <ac:chgData name="Jimin Hyun" userId="0288e339-f229-4ef7-af6c-9105033c7845" providerId="ADAL" clId="{757C3268-3831-4CAA-9A06-3E5CFDC226C2}" dt="2024-05-21T13:12:02.682" v="6" actId="1076"/>
          <ac:cxnSpMkLst>
            <pc:docMk/>
            <pc:sldMk cId="1023201734" sldId="256"/>
            <ac:cxnSpMk id="7" creationId="{EF5A7CA9-9B57-0E21-0450-85C7397375C2}"/>
          </ac:cxnSpMkLst>
        </pc:cxnChg>
        <pc:cxnChg chg="add mod">
          <ac:chgData name="Jimin Hyun" userId="0288e339-f229-4ef7-af6c-9105033c7845" providerId="ADAL" clId="{757C3268-3831-4CAA-9A06-3E5CFDC226C2}" dt="2024-05-21T13:12:07.911" v="8" actId="1076"/>
          <ac:cxnSpMkLst>
            <pc:docMk/>
            <pc:sldMk cId="1023201734" sldId="256"/>
            <ac:cxnSpMk id="8" creationId="{F04ED707-566E-6562-ACD1-7D06390F1DB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6338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2759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0693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0397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2264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6889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4891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2990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1050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4896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1489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75FA7F-B929-4CDE-871A-28384C614BDB}" type="datetimeFigureOut">
              <a:rPr lang="ko-KR" altLang="en-US" smtClean="0"/>
              <a:t>2024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D1E262-7AC8-4DE2-95B6-77A0984615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769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7C6AFD1-CAE8-40F0-8F9C-CE74B1786847}"/>
              </a:ext>
            </a:extLst>
          </p:cNvPr>
          <p:cNvSpPr txBox="1"/>
          <p:nvPr/>
        </p:nvSpPr>
        <p:spPr>
          <a:xfrm>
            <a:off x="144030" y="182989"/>
            <a:ext cx="4553576" cy="3000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ko-KR" sz="1350" b="1" dirty="0">
                <a:latin typeface="나눔고딕" pitchFamily="2" charset="-127"/>
                <a:ea typeface="나눔고딕" pitchFamily="2" charset="-127"/>
              </a:rPr>
              <a:t>Microorganism polyphenol  LC MS/MS analysis method</a:t>
            </a:r>
            <a:endParaRPr lang="ko-KR" altLang="en-US" sz="1350" b="1" dirty="0">
              <a:latin typeface="나눔고딕" pitchFamily="2" charset="-127"/>
              <a:ea typeface="나눔고딕" pitchFamily="2" charset="-127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B4FF07-4F7E-4C1C-9355-F5CDCEDFD07A}"/>
              </a:ext>
            </a:extLst>
          </p:cNvPr>
          <p:cNvSpPr txBox="1"/>
          <p:nvPr/>
        </p:nvSpPr>
        <p:spPr>
          <a:xfrm>
            <a:off x="144030" y="500005"/>
            <a:ext cx="8786813" cy="22372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- LC (</a:t>
            </a:r>
            <a:r>
              <a:rPr lang="ko-KR" altLang="en-US" sz="1200" dirty="0">
                <a:latin typeface="나눔고딕" pitchFamily="2" charset="-127"/>
                <a:ea typeface="나눔고딕" pitchFamily="2" charset="-127"/>
              </a:rPr>
              <a:t>모델명 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: SYNAPT XS, </a:t>
            </a:r>
            <a:r>
              <a:rPr lang="ko-KR" altLang="en-US" sz="1200" dirty="0">
                <a:latin typeface="나눔고딕" pitchFamily="2" charset="-127"/>
                <a:ea typeface="나눔고딕" pitchFamily="2" charset="-127"/>
              </a:rPr>
              <a:t>제작사 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: WATERS)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- Column : WATERS BEH C18 2.1*100, 1.7 </a:t>
            </a:r>
            <a:r>
              <a:rPr lang="el-GR" altLang="ko-KR" sz="1200" dirty="0">
                <a:ea typeface="나눔고딕" pitchFamily="2" charset="-127"/>
              </a:rPr>
              <a:t>μ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m</a:t>
            </a:r>
          </a:p>
          <a:p>
            <a:pPr marL="171450" indent="-171450">
              <a:lnSpc>
                <a:spcPct val="200000"/>
              </a:lnSpc>
              <a:buFontTx/>
              <a:buChar char="-"/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Flow rate : 0.3 mL/min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- Injection volume : 1 </a:t>
            </a:r>
            <a:r>
              <a:rPr lang="el-GR" altLang="ko-KR" sz="1200" dirty="0">
                <a:ea typeface="나눔고딕" pitchFamily="2" charset="-127"/>
              </a:rPr>
              <a:t>μ</a:t>
            </a:r>
            <a:r>
              <a:rPr lang="en-US" altLang="ko-KR" sz="1200" dirty="0">
                <a:ea typeface="나눔고딕" pitchFamily="2" charset="-127"/>
              </a:rPr>
              <a:t>L</a:t>
            </a:r>
            <a:endParaRPr lang="en-US" altLang="ko-KR" sz="1200" dirty="0">
              <a:latin typeface="나눔고딕" pitchFamily="2" charset="-127"/>
              <a:ea typeface="나눔고딕" pitchFamily="2" charset="-127"/>
            </a:endParaRP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- Solvent A : water with 0.1% Formic acid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- Solvent B : ACN with 0.1% Formic acid</a:t>
            </a:r>
            <a:endParaRPr lang="ko-KR" altLang="en-US" sz="1200" dirty="0">
              <a:latin typeface="나눔고딕" pitchFamily="2" charset="-127"/>
              <a:ea typeface="나눔고딕" pitchFamily="2" charset="-127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5B9390F-07B4-751A-E7FC-1CED25631C34}"/>
              </a:ext>
            </a:extLst>
          </p:cNvPr>
          <p:cNvSpPr txBox="1"/>
          <p:nvPr/>
        </p:nvSpPr>
        <p:spPr>
          <a:xfrm>
            <a:off x="84762" y="2655655"/>
            <a:ext cx="7158470" cy="41052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Source : ESI positive mode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Mass range : 100-1200 m/z 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Capillary : POS(3 kV) 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Sampling cone : 40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Source Temp. : POS(120 ℃) 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</a:t>
            </a:r>
            <a:r>
              <a:rPr lang="en-US" altLang="ko-KR" sz="1200" dirty="0" err="1">
                <a:latin typeface="나눔고딕" pitchFamily="2" charset="-127"/>
                <a:ea typeface="나눔고딕" pitchFamily="2" charset="-127"/>
              </a:rPr>
              <a:t>Desorvation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Temp. : POS(350 ℃) 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Cone gas: 50 L/H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</a:t>
            </a:r>
            <a:r>
              <a:rPr lang="en-US" altLang="ko-KR" sz="1200" dirty="0" err="1">
                <a:latin typeface="나눔고딕" pitchFamily="2" charset="-127"/>
                <a:ea typeface="나눔고딕" pitchFamily="2" charset="-127"/>
              </a:rPr>
              <a:t>Desorvation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gas : 600 L/H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- </a:t>
            </a:r>
            <a:r>
              <a:rPr lang="en-US" altLang="ko-KR" sz="1200" dirty="0" err="1">
                <a:latin typeface="나눔고딕" pitchFamily="2" charset="-127"/>
                <a:ea typeface="나눔고딕" pitchFamily="2" charset="-127"/>
              </a:rPr>
              <a:t>MSe</a:t>
            </a: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Continuum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   Function 1: Low energy-Trap Collision Energy: 6V</a:t>
            </a:r>
          </a:p>
          <a:p>
            <a:pPr>
              <a:lnSpc>
                <a:spcPct val="200000"/>
              </a:lnSpc>
            </a:pPr>
            <a:r>
              <a:rPr lang="en-US" altLang="ko-KR" sz="1200" dirty="0">
                <a:latin typeface="나눔고딕" pitchFamily="2" charset="-127"/>
                <a:ea typeface="나눔고딕" pitchFamily="2" charset="-127"/>
              </a:rPr>
              <a:t>    Function 2: High energy-Ramp Trap Collision Energy: 20-45V</a:t>
            </a:r>
            <a:endParaRPr lang="ko-KR" altLang="en-US" sz="1200" dirty="0">
              <a:latin typeface="나눔고딕" pitchFamily="2" charset="-127"/>
              <a:ea typeface="나눔고딕" pitchFamily="2" charset="-127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F92EDE9-0453-53FE-8FFF-C49EDCF28D13}"/>
              </a:ext>
            </a:extLst>
          </p:cNvPr>
          <p:cNvSpPr txBox="1"/>
          <p:nvPr/>
        </p:nvSpPr>
        <p:spPr>
          <a:xfrm>
            <a:off x="5412713" y="1176804"/>
            <a:ext cx="2895340" cy="5185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600" dirty="0">
                <a:latin typeface="+mj-lt"/>
              </a:rPr>
              <a:t>&lt; Gradient method &gt;</a:t>
            </a:r>
            <a:endParaRPr lang="ko-KR" altLang="en-US" sz="1600" dirty="0">
              <a:latin typeface="+mj-lt"/>
            </a:endParaRPr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24FD0C32-EE00-ED9A-858A-6FE5DD837C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5746432"/>
              </p:ext>
            </p:extLst>
          </p:nvPr>
        </p:nvGraphicFramePr>
        <p:xfrm>
          <a:off x="5412713" y="1794638"/>
          <a:ext cx="2920866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3622">
                  <a:extLst>
                    <a:ext uri="{9D8B030D-6E8A-4147-A177-3AD203B41FA5}">
                      <a16:colId xmlns:a16="http://schemas.microsoft.com/office/drawing/2014/main" val="3477422904"/>
                    </a:ext>
                  </a:extLst>
                </a:gridCol>
                <a:gridCol w="973622">
                  <a:extLst>
                    <a:ext uri="{9D8B030D-6E8A-4147-A177-3AD203B41FA5}">
                      <a16:colId xmlns:a16="http://schemas.microsoft.com/office/drawing/2014/main" val="2385484185"/>
                    </a:ext>
                  </a:extLst>
                </a:gridCol>
                <a:gridCol w="973622">
                  <a:extLst>
                    <a:ext uri="{9D8B030D-6E8A-4147-A177-3AD203B41FA5}">
                      <a16:colId xmlns:a16="http://schemas.microsoft.com/office/drawing/2014/main" val="63709112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Min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B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3018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9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21473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9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9327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6118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27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6432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27.01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9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51900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9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13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3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9050" cap="flat" cmpd="sng" algn="ctr">
                      <a:solidFill>
                        <a:schemeClr val="bg2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66561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18091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D62A3B1C-4329-ECE8-0FC1-D5110CB814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24" y="0"/>
            <a:ext cx="900475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9B3BAF7-F36D-9587-F940-A60DDDF4BD77}"/>
              </a:ext>
            </a:extLst>
          </p:cNvPr>
          <p:cNvSpPr txBox="1"/>
          <p:nvPr/>
        </p:nvSpPr>
        <p:spPr>
          <a:xfrm>
            <a:off x="850118" y="791661"/>
            <a:ext cx="39837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9.72 / 10.36 / 14.26 / 26.89</a:t>
            </a:r>
          </a:p>
          <a:p>
            <a:endParaRPr lang="en-US" altLang="ko-KR" sz="1200" b="1" dirty="0">
              <a:solidFill>
                <a:srgbClr val="FF0000"/>
              </a:solidFill>
              <a:latin typeface="나눔고딕" pitchFamily="2" charset="-127"/>
              <a:ea typeface="나눔고딕" pitchFamily="2" charset="-127"/>
            </a:endParaRPr>
          </a:p>
          <a:p>
            <a:r>
              <a:rPr lang="en-US" altLang="ko-KR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--&gt; Peak retention time </a:t>
            </a:r>
            <a:r>
              <a:rPr lang="ko-KR" altLang="en-US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이랑 겹치는 </a:t>
            </a:r>
            <a:r>
              <a:rPr lang="en-US" altLang="ko-KR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id compound </a:t>
            </a:r>
            <a:r>
              <a:rPr lang="ko-KR" altLang="en-US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없음</a:t>
            </a:r>
            <a:r>
              <a:rPr lang="en-US" altLang="ko-KR" sz="1200" b="1" dirty="0">
                <a:solidFill>
                  <a:srgbClr val="FF0000"/>
                </a:solidFill>
                <a:latin typeface="나눔고딕" pitchFamily="2" charset="-127"/>
                <a:ea typeface="나눔고딕" pitchFamily="2" charset="-127"/>
              </a:rPr>
              <a:t> </a:t>
            </a:r>
            <a:endParaRPr lang="ko-KR" altLang="en-US" sz="1200" b="1" dirty="0">
              <a:solidFill>
                <a:srgbClr val="FF0000"/>
              </a:solidFill>
              <a:latin typeface="나눔고딕" pitchFamily="2" charset="-127"/>
              <a:ea typeface="나눔고딕" pitchFamily="2" charset="-127"/>
            </a:endParaRPr>
          </a:p>
        </p:txBody>
      </p:sp>
      <p:cxnSp>
        <p:nvCxnSpPr>
          <p:cNvPr id="3" name="직선 화살표 연결선 2">
            <a:extLst>
              <a:ext uri="{FF2B5EF4-FFF2-40B4-BE49-F238E27FC236}">
                <a16:creationId xmlns:a16="http://schemas.microsoft.com/office/drawing/2014/main" id="{BB3A98C2-9172-1954-098F-41944A5D5CCB}"/>
              </a:ext>
            </a:extLst>
          </p:cNvPr>
          <p:cNvCxnSpPr/>
          <p:nvPr/>
        </p:nvCxnSpPr>
        <p:spPr>
          <a:xfrm>
            <a:off x="3081130" y="5678557"/>
            <a:ext cx="0" cy="21203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" name="직선 화살표 연결선 3">
            <a:extLst>
              <a:ext uri="{FF2B5EF4-FFF2-40B4-BE49-F238E27FC236}">
                <a16:creationId xmlns:a16="http://schemas.microsoft.com/office/drawing/2014/main" id="{CFCC225B-554D-AAA9-03EA-E8A154699B33}"/>
              </a:ext>
            </a:extLst>
          </p:cNvPr>
          <p:cNvCxnSpPr/>
          <p:nvPr/>
        </p:nvCxnSpPr>
        <p:spPr>
          <a:xfrm>
            <a:off x="3346174" y="5466523"/>
            <a:ext cx="0" cy="21203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직선 화살표 연결선 6">
            <a:extLst>
              <a:ext uri="{FF2B5EF4-FFF2-40B4-BE49-F238E27FC236}">
                <a16:creationId xmlns:a16="http://schemas.microsoft.com/office/drawing/2014/main" id="{EF5A7CA9-9B57-0E21-0450-85C7397375C2}"/>
              </a:ext>
            </a:extLst>
          </p:cNvPr>
          <p:cNvCxnSpPr/>
          <p:nvPr/>
        </p:nvCxnSpPr>
        <p:spPr>
          <a:xfrm>
            <a:off x="4313583" y="5678557"/>
            <a:ext cx="0" cy="21203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직선 화살표 연결선 7">
            <a:extLst>
              <a:ext uri="{FF2B5EF4-FFF2-40B4-BE49-F238E27FC236}">
                <a16:creationId xmlns:a16="http://schemas.microsoft.com/office/drawing/2014/main" id="{F04ED707-566E-6562-ACD1-7D06390F1DB5}"/>
              </a:ext>
            </a:extLst>
          </p:cNvPr>
          <p:cNvCxnSpPr/>
          <p:nvPr/>
        </p:nvCxnSpPr>
        <p:spPr>
          <a:xfrm>
            <a:off x="7653131" y="5678557"/>
            <a:ext cx="0" cy="21203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23201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</TotalTime>
  <Words>202</Words>
  <Application>Microsoft Office PowerPoint</Application>
  <PresentationFormat>화면 슬라이드 쇼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나눔고딕</vt:lpstr>
      <vt:lpstr>Aptos</vt:lpstr>
      <vt:lpstr>Aptos Display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석민 이</dc:creator>
  <cp:lastModifiedBy>Jimin Hyun</cp:lastModifiedBy>
  <cp:revision>8</cp:revision>
  <dcterms:created xsi:type="dcterms:W3CDTF">2024-05-20T03:28:49Z</dcterms:created>
  <dcterms:modified xsi:type="dcterms:W3CDTF">2024-05-21T13:12:08Z</dcterms:modified>
</cp:coreProperties>
</file>